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88163" cy="10018713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336" autoAdjust="0"/>
    <p:restoredTop sz="94660"/>
  </p:normalViewPr>
  <p:slideViewPr>
    <p:cSldViewPr snapToGrid="0">
      <p:cViewPr varScale="1">
        <p:scale>
          <a:sx n="61" d="100"/>
          <a:sy n="61" d="100"/>
        </p:scale>
        <p:origin x="3029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&#51312;&#54788;&#46041;\Desktop\2017%20&#45453;&#47548;&#48512;%20&#48156;&#54952;&#44260;&#52649;%20&#44148;&#44053;&#44592;&#45733;&#49885;&#54408;%20&#44284;&#51228;\&#48156;&#54952;&#44260;&#52649;&#51032;%20&#44036;&#50516;&#49464;&#54252;%20&#49324;&#47736;&#54952;&#44284;%20(SCI)\180615%20&#48264;&#45936;&#44592;%20HepG2%20SRB%20&#44208;&#44284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199835449638611"/>
          <c:y val="5.5635847646189465E-2"/>
          <c:w val="0.84066349364763093"/>
          <c:h val="0.741532658083267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U$33</c:f>
              <c:strCache>
                <c:ptCount val="1"/>
                <c:pt idx="0">
                  <c:v>FSWE</c:v>
                </c:pt>
              </c:strCache>
            </c:strRef>
          </c:tx>
          <c:spPr>
            <a:noFill/>
            <a:ln w="63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7542-401B-9C9C-9A7D6BDFC6EF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U$43:$AC$43</c:f>
                <c:numCache>
                  <c:formatCode>General</c:formatCode>
                  <c:ptCount val="9"/>
                  <c:pt idx="0">
                    <c:v>2.7412264460641635</c:v>
                  </c:pt>
                  <c:pt idx="1">
                    <c:v>3.5833549967950646</c:v>
                  </c:pt>
                  <c:pt idx="2">
                    <c:v>3.3713496802327669</c:v>
                  </c:pt>
                  <c:pt idx="3">
                    <c:v>5.0840153921362221</c:v>
                  </c:pt>
                  <c:pt idx="4">
                    <c:v>2.9613311096067227</c:v>
                  </c:pt>
                  <c:pt idx="5">
                    <c:v>1.583921331338781</c:v>
                  </c:pt>
                  <c:pt idx="6">
                    <c:v>2.6457816804762895</c:v>
                  </c:pt>
                  <c:pt idx="7">
                    <c:v>1.5781824670668998</c:v>
                  </c:pt>
                  <c:pt idx="8">
                    <c:v>3.685709605771149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B$3:$J$3</c:f>
              <c:strCache>
                <c:ptCount val="9"/>
                <c:pt idx="0">
                  <c:v>Control</c:v>
                </c:pt>
                <c:pt idx="1">
                  <c:v>10</c:v>
                </c:pt>
                <c:pt idx="2">
                  <c:v>25</c:v>
                </c:pt>
                <c:pt idx="3">
                  <c:v>50</c:v>
                </c:pt>
                <c:pt idx="4">
                  <c:v>100</c:v>
                </c:pt>
                <c:pt idx="5">
                  <c:v>200</c:v>
                </c:pt>
                <c:pt idx="6">
                  <c:v>300</c:v>
                </c:pt>
                <c:pt idx="7">
                  <c:v>400</c:v>
                </c:pt>
                <c:pt idx="8">
                  <c:v>500</c:v>
                </c:pt>
              </c:strCache>
            </c:strRef>
          </c:cat>
          <c:val>
            <c:numRef>
              <c:f>Sheet1!$U$42:$AC$42</c:f>
              <c:numCache>
                <c:formatCode>General</c:formatCode>
                <c:ptCount val="9"/>
                <c:pt idx="0">
                  <c:v>100</c:v>
                </c:pt>
                <c:pt idx="1">
                  <c:v>98.29366861248316</c:v>
                </c:pt>
                <c:pt idx="2">
                  <c:v>96.6995958688819</c:v>
                </c:pt>
                <c:pt idx="3">
                  <c:v>97.507858105074106</c:v>
                </c:pt>
                <c:pt idx="4">
                  <c:v>95.577009429726104</c:v>
                </c:pt>
                <c:pt idx="5">
                  <c:v>95.57700942972609</c:v>
                </c:pt>
                <c:pt idx="6">
                  <c:v>95.711719802424795</c:v>
                </c:pt>
                <c:pt idx="7">
                  <c:v>95.981140547822193</c:v>
                </c:pt>
                <c:pt idx="8">
                  <c:v>89.9416255051639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542-401B-9C9C-9A7D6BDFC6EF}"/>
            </c:ext>
          </c:extLst>
        </c:ser>
        <c:ser>
          <c:idx val="1"/>
          <c:order val="1"/>
          <c:tx>
            <c:strRef>
              <c:f>Sheet1!$V$33</c:f>
              <c:strCache>
                <c:ptCount val="1"/>
                <c:pt idx="0">
                  <c:v>FSEE</c:v>
                </c:pt>
              </c:strCache>
            </c:strRef>
          </c:tx>
          <c:spPr>
            <a:solidFill>
              <a:schemeClr val="tx1"/>
            </a:solidFill>
            <a:ln w="635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U$54:$AC$54</c:f>
                <c:numCache>
                  <c:formatCode>General</c:formatCode>
                  <c:ptCount val="9"/>
                  <c:pt idx="0">
                    <c:v>2.7412264460641635</c:v>
                  </c:pt>
                  <c:pt idx="1">
                    <c:v>7.8561483226708342</c:v>
                  </c:pt>
                  <c:pt idx="2">
                    <c:v>9.3339805305720809</c:v>
                  </c:pt>
                  <c:pt idx="3">
                    <c:v>1.7820507259078922</c:v>
                  </c:pt>
                  <c:pt idx="4">
                    <c:v>6.2991805202918494</c:v>
                  </c:pt>
                  <c:pt idx="5">
                    <c:v>2.503342589091397</c:v>
                  </c:pt>
                  <c:pt idx="6">
                    <c:v>5.7583760493466123</c:v>
                  </c:pt>
                  <c:pt idx="7">
                    <c:v>0.96751061636350999</c:v>
                  </c:pt>
                  <c:pt idx="8">
                    <c:v>0.5648740738845551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U$53:$AC$53</c:f>
              <c:numCache>
                <c:formatCode>General</c:formatCode>
                <c:ptCount val="9"/>
                <c:pt idx="0">
                  <c:v>100</c:v>
                </c:pt>
                <c:pt idx="1">
                  <c:v>95.150426582846876</c:v>
                </c:pt>
                <c:pt idx="2">
                  <c:v>99.887741356084419</c:v>
                </c:pt>
                <c:pt idx="3">
                  <c:v>95.64436461607545</c:v>
                </c:pt>
                <c:pt idx="4">
                  <c:v>93.107319263583292</c:v>
                </c:pt>
                <c:pt idx="5">
                  <c:v>83.565334530758875</c:v>
                </c:pt>
                <c:pt idx="6">
                  <c:v>24.786708576560397</c:v>
                </c:pt>
                <c:pt idx="7">
                  <c:v>5.5006735518634926</c:v>
                </c:pt>
                <c:pt idx="8">
                  <c:v>4.46789402784014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7542-401B-9C9C-9A7D6BDFC6E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45443824"/>
        <c:axId val="445446176"/>
      </c:barChart>
      <c:catAx>
        <c:axId val="445443824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445446176"/>
        <c:crosses val="autoZero"/>
        <c:auto val="1"/>
        <c:lblAlgn val="ctr"/>
        <c:lblOffset val="100"/>
        <c:noMultiLvlLbl val="0"/>
      </c:catAx>
      <c:valAx>
        <c:axId val="445446176"/>
        <c:scaling>
          <c:orientation val="minMax"/>
          <c:max val="14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ko-KR"/>
                  <a:t>Cell</a:t>
                </a:r>
                <a:r>
                  <a:rPr lang="en-US" altLang="ko-KR" baseline="0"/>
                  <a:t> viability (%)</a:t>
                </a:r>
                <a:endParaRPr lang="ko-KR" altLang="en-US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ko-KR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445443824"/>
        <c:crosses val="autoZero"/>
        <c:crossBetween val="between"/>
      </c:valAx>
      <c:spPr>
        <a:noFill/>
        <a:ln w="6350">
          <a:solidFill>
            <a:schemeClr val="tx1"/>
          </a:solidFill>
        </a:ln>
        <a:effectLst/>
      </c:spPr>
    </c:plotArea>
    <c:legend>
      <c:legendPos val="r"/>
      <c:layout>
        <c:manualLayout>
          <c:xMode val="edge"/>
          <c:yMode val="edge"/>
          <c:x val="0.66018019386898807"/>
          <c:y val="7.5825248479572241E-2"/>
          <c:w val="0.29596273184679722"/>
          <c:h val="0.1149674767251393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ko-KR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4C11E6-B65B-4D7B-8A79-66A826D9A87C}" type="datetimeFigureOut">
              <a:rPr lang="ko-KR" altLang="en-US" smtClean="0"/>
              <a:t>2019-07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B7340E-0E72-4796-9368-A54225BB380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128216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4C11E6-B65B-4D7B-8A79-66A826D9A87C}" type="datetimeFigureOut">
              <a:rPr lang="ko-KR" altLang="en-US" smtClean="0"/>
              <a:t>2019-07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B7340E-0E72-4796-9368-A54225BB380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132598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4C11E6-B65B-4D7B-8A79-66A826D9A87C}" type="datetimeFigureOut">
              <a:rPr lang="ko-KR" altLang="en-US" smtClean="0"/>
              <a:t>2019-07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B7340E-0E72-4796-9368-A54225BB380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814443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4C11E6-B65B-4D7B-8A79-66A826D9A87C}" type="datetimeFigureOut">
              <a:rPr lang="ko-KR" altLang="en-US" smtClean="0"/>
              <a:t>2019-07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B7340E-0E72-4796-9368-A54225BB380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57033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4C11E6-B65B-4D7B-8A79-66A826D9A87C}" type="datetimeFigureOut">
              <a:rPr lang="ko-KR" altLang="en-US" smtClean="0"/>
              <a:t>2019-07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B7340E-0E72-4796-9368-A54225BB380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065518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4C11E6-B65B-4D7B-8A79-66A826D9A87C}" type="datetimeFigureOut">
              <a:rPr lang="ko-KR" altLang="en-US" smtClean="0"/>
              <a:t>2019-07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B7340E-0E72-4796-9368-A54225BB380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275347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4C11E6-B65B-4D7B-8A79-66A826D9A87C}" type="datetimeFigureOut">
              <a:rPr lang="ko-KR" altLang="en-US" smtClean="0"/>
              <a:t>2019-07-1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B7340E-0E72-4796-9368-A54225BB380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635544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4C11E6-B65B-4D7B-8A79-66A826D9A87C}" type="datetimeFigureOut">
              <a:rPr lang="ko-KR" altLang="en-US" smtClean="0"/>
              <a:t>2019-07-1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B7340E-0E72-4796-9368-A54225BB380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214943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4C11E6-B65B-4D7B-8A79-66A826D9A87C}" type="datetimeFigureOut">
              <a:rPr lang="ko-KR" altLang="en-US" smtClean="0"/>
              <a:t>2019-07-1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B7340E-0E72-4796-9368-A54225BB380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899341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4C11E6-B65B-4D7B-8A79-66A826D9A87C}" type="datetimeFigureOut">
              <a:rPr lang="ko-KR" altLang="en-US" smtClean="0"/>
              <a:t>2019-07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B7340E-0E72-4796-9368-A54225BB380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309433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4C11E6-B65B-4D7B-8A79-66A826D9A87C}" type="datetimeFigureOut">
              <a:rPr lang="ko-KR" altLang="en-US" smtClean="0"/>
              <a:t>2019-07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B7340E-0E72-4796-9368-A54225BB380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593828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4C11E6-B65B-4D7B-8A79-66A826D9A87C}" type="datetimeFigureOut">
              <a:rPr lang="ko-KR" altLang="en-US" smtClean="0"/>
              <a:t>2019-07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B7340E-0E72-4796-9368-A54225BB380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967822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3" name="차트 3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8203540"/>
              </p:ext>
            </p:extLst>
          </p:nvPr>
        </p:nvGraphicFramePr>
        <p:xfrm>
          <a:off x="1133261" y="2116375"/>
          <a:ext cx="4633232" cy="25109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6" name="직선 연결선 5"/>
          <p:cNvCxnSpPr/>
          <p:nvPr/>
        </p:nvCxnSpPr>
        <p:spPr>
          <a:xfrm>
            <a:off x="2330777" y="4443571"/>
            <a:ext cx="3198487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2596979" y="4443571"/>
            <a:ext cx="26660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 smtClean="0">
                <a:latin typeface="Times New Roman" pitchFamily="18" charset="0"/>
                <a:cs typeface="Times New Roman" pitchFamily="18" charset="0"/>
              </a:rPr>
              <a:t>Concentration </a:t>
            </a:r>
            <a:r>
              <a:rPr lang="en-US" altLang="ko-KR" sz="900" b="1" smtClean="0">
                <a:latin typeface="Times New Roman" pitchFamily="18" charset="0"/>
                <a:cs typeface="Times New Roman" pitchFamily="18" charset="0"/>
              </a:rPr>
              <a:t>(µg/mL)</a:t>
            </a:r>
            <a:endParaRPr lang="ko-KR" altLang="en-US" sz="9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4442428" y="3523340"/>
            <a:ext cx="4043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 smtClean="0">
                <a:latin typeface="Times New Roman" pitchFamily="18" charset="0"/>
                <a:cs typeface="Times New Roman" pitchFamily="18" charset="0"/>
              </a:rPr>
              <a:t>***</a:t>
            </a:r>
            <a:endParaRPr lang="ko-KR" altLang="en-US" sz="9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4876658" y="3835963"/>
            <a:ext cx="4043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 smtClean="0">
                <a:latin typeface="Times New Roman" pitchFamily="18" charset="0"/>
                <a:cs typeface="Times New Roman" pitchFamily="18" charset="0"/>
              </a:rPr>
              <a:t>***</a:t>
            </a:r>
            <a:endParaRPr lang="ko-KR" altLang="en-US" sz="9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5326579" y="3835963"/>
            <a:ext cx="4043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 smtClean="0">
                <a:latin typeface="Times New Roman" pitchFamily="18" charset="0"/>
                <a:cs typeface="Times New Roman" pitchFamily="18" charset="0"/>
              </a:rPr>
              <a:t>***</a:t>
            </a:r>
            <a:endParaRPr lang="ko-KR" altLang="en-US" sz="9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" name="직사각형 1"/>
          <p:cNvSpPr/>
          <p:nvPr/>
        </p:nvSpPr>
        <p:spPr>
          <a:xfrm>
            <a:off x="950412" y="4751971"/>
            <a:ext cx="5513018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2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data </a:t>
            </a:r>
            <a:r>
              <a:rPr lang="en-US" altLang="ko-KR" sz="12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2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ko-KR" sz="12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growth inhibitory effects on HepG2 hepatocellular carcinoma cells treated with </a:t>
            </a:r>
            <a:r>
              <a:rPr lang="en-US" altLang="ko-KR" sz="12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ermented silkworm larva water extract (FSWE) </a:t>
            </a: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fermented silkworm </a:t>
            </a:r>
            <a:r>
              <a:rPr lang="en-US" altLang="ko-KR" sz="12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rva ethanol </a:t>
            </a: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tract </a:t>
            </a:r>
            <a:r>
              <a:rPr lang="en-US" altLang="ko-KR" sz="12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SEE) </a:t>
            </a: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24 h. </a:t>
            </a:r>
            <a:r>
              <a:rPr lang="en-US" altLang="ko-KR" sz="12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 </a:t>
            </a: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ability was measured by SRB assay. </a:t>
            </a:r>
            <a:r>
              <a:rPr lang="en-US" altLang="ko-KR" sz="1200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ta values were expressed as </a:t>
            </a:r>
            <a:r>
              <a:rPr lang="en-US" altLang="ko-KR" sz="1200" kern="1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an±SD</a:t>
            </a:r>
            <a:r>
              <a:rPr lang="en-US" altLang="ko-KR" sz="1200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f triplicate determinations. </a:t>
            </a: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gnificant differences were compared with the control at *p&lt;0.05, **p&lt;0.01, and ***p&lt;0.001 using one-way ANOVA. </a:t>
            </a:r>
            <a:endParaRPr lang="ko-KR" altLang="ko-KR" sz="10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765034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66</TotalTime>
  <Words>85</Words>
  <Application>Microsoft Office PowerPoint</Application>
  <PresentationFormat>A4 용지(210x297mm)</PresentationFormat>
  <Paragraphs>6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조현동</dc:creator>
  <cp:lastModifiedBy>조현동</cp:lastModifiedBy>
  <cp:revision>70</cp:revision>
  <cp:lastPrinted>2018-08-16T07:14:38Z</cp:lastPrinted>
  <dcterms:created xsi:type="dcterms:W3CDTF">2018-07-05T12:01:46Z</dcterms:created>
  <dcterms:modified xsi:type="dcterms:W3CDTF">2019-07-15T11:35:18Z</dcterms:modified>
</cp:coreProperties>
</file>